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C9A61B-FCAD-4708-9067-9EA286867DA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866746-E468-47D6-9EC9-982D08E2F8E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AAD64B-B091-4700-B48C-FC7EC274892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C29FB5-AEB2-4BA0-9AF5-7847F5DD2F0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B7CDE4-BBFC-4D9D-BE15-DADAFCFF7D0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3996C0-F3DA-4B9D-993E-631FD0293C0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F6E9F7-43CD-440D-ADC4-80D7307CD95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D21805-B371-4870-9E2A-508838A2A58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8FC48E-D30D-4D03-96D2-3EA99CF5E9E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B48376-A1DD-4133-B56F-23302C7208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1D27B9-7E75-4BF9-9D1E-30E7D501705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9235EB-66AC-4879-88E5-E1942A6BA2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3C5BD98-D5F1-490A-92ED-8734A1668511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ssembly and annotation of body-wide human microbiome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Content Placeholder 3" descr=""/>
          <p:cNvPicPr/>
          <p:nvPr/>
        </p:nvPicPr>
        <p:blipFill>
          <a:blip r:embed="rId1"/>
          <a:stretch/>
        </p:blipFill>
        <p:spPr>
          <a:xfrm>
            <a:off x="2171880" y="2832120"/>
            <a:ext cx="4800600" cy="122400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5" descr=""/>
          <p:cNvPicPr/>
          <p:nvPr/>
        </p:nvPicPr>
        <p:blipFill>
          <a:blip r:embed="rId2"/>
          <a:stretch/>
        </p:blipFill>
        <p:spPr>
          <a:xfrm>
            <a:off x="6985080" y="6222960"/>
            <a:ext cx="1333440" cy="279360"/>
          </a:xfrm>
          <a:prstGeom prst="rect">
            <a:avLst/>
          </a:prstGeom>
          <a:ln w="0">
            <a:noFill/>
          </a:ln>
        </p:spPr>
      </p:pic>
      <p:sp>
        <p:nvSpPr>
          <p:cNvPr id="44" name="Title 1"/>
          <p:cNvSpPr/>
          <p:nvPr/>
        </p:nvSpPr>
        <p:spPr>
          <a:xfrm>
            <a:off x="444600" y="5851440"/>
            <a:ext cx="822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J Lloyd-Price </a:t>
            </a:r>
            <a:r>
              <a:rPr b="0" i="1" lang="fr-FR" sz="1200" spc="-1" strike="noStrike">
                <a:solidFill>
                  <a:srgbClr val="000000"/>
                </a:solidFill>
                <a:latin typeface="Arial"/>
              </a:rPr>
              <a:t>et al. Nature</a:t>
            </a: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1–6 (2017) doi:10.1038/nature23889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9-16T09:00:53Z</dcterms:created>
  <dc:creator>ravikumar.n</dc:creator>
  <dc:description/>
  <dc:language>en-US</dc:language>
  <cp:lastModifiedBy>ravikumar.n</cp:lastModifiedBy>
  <dcterms:modified xsi:type="dcterms:W3CDTF">2017-09-16T09:00:56Z</dcterms:modified>
  <cp:revision>1</cp:revision>
  <dc:subject/>
  <dc:title>Assembly and annotation of body-wide human microbiomes</dc:title>
</cp:coreProperties>
</file>